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998" autoAdjust="0"/>
    <p:restoredTop sz="94660"/>
  </p:normalViewPr>
  <p:slideViewPr>
    <p:cSldViewPr snapToGrid="0">
      <p:cViewPr varScale="1">
        <p:scale>
          <a:sx n="105" d="100"/>
          <a:sy n="105" d="100"/>
        </p:scale>
        <p:origin x="68" y="2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DADA48-92A5-8DAD-209C-0866F8BDA00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4D4CC01-27CB-E5E4-DA06-7484E88ADC5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9EEE999-9108-8AB2-3837-F05B3CE849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C0657E-42FA-4F9A-99A4-C6AA05267C81}" type="datetimeFigureOut">
              <a:rPr lang="en-US" smtClean="0"/>
              <a:t>1/2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323E1D6-AD02-12E5-6638-D018CB8241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5E50A78-A175-78ED-A35F-671B13B8E7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A54FAF-3A03-421A-B73C-3C88FF03EB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93060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CAF0C4-B02D-C69C-4CAE-356703E5960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B90E46A-E4A1-5EE3-9EBF-5A61E387616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65069C3-AFE3-FE8B-854B-BDCA2D8F95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C0657E-42FA-4F9A-99A4-C6AA05267C81}" type="datetimeFigureOut">
              <a:rPr lang="en-US" smtClean="0"/>
              <a:t>1/2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14877F3-019F-03F7-E58E-A07865C4AD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173478A-7B10-6692-8455-D28A5F669B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A54FAF-3A03-421A-B73C-3C88FF03EB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43384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27B433B-3939-AEB7-BF1C-8DEC6E02CAF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F00CF9B-8343-0CAE-7DF6-82B99031A91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BFCFA33-C5AB-27B0-53FD-6FA1CD1120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C0657E-42FA-4F9A-99A4-C6AA05267C81}" type="datetimeFigureOut">
              <a:rPr lang="en-US" smtClean="0"/>
              <a:t>1/2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60208B0-EB78-68A7-1A53-181D197B2E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CF8BE9C-5F7B-7939-5B28-C0814BB034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A54FAF-3A03-421A-B73C-3C88FF03EB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07388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27936D3-CD76-AEBD-37C6-6BBFA575A52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BD742CC-0064-1575-02B0-0E92C2D01C1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CEED6A2-A167-7670-6025-939EEAB88D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C0657E-42FA-4F9A-99A4-C6AA05267C81}" type="datetimeFigureOut">
              <a:rPr lang="en-US" smtClean="0"/>
              <a:t>1/2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3FDD4C3-2806-39FC-DB23-0CE7ABCA48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234C910-EB52-B674-0F68-11973649C8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A54FAF-3A03-421A-B73C-3C88FF03EB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22817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95C5B1-001A-0F9B-18F2-735464C1A6E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95E56B9-8A52-CA23-8646-CA4B2B79516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92C465D-0CA5-309E-2E44-F1191E440A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C0657E-42FA-4F9A-99A4-C6AA05267C81}" type="datetimeFigureOut">
              <a:rPr lang="en-US" smtClean="0"/>
              <a:t>1/2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A9F4CE5-DBE6-67BA-A016-78ED154762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0FBF595-BBB6-CBD2-023E-BEA5E24CEF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A54FAF-3A03-421A-B73C-3C88FF03EB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13255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3E598E0-BF7D-D817-28A0-81688BFA735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E686BB2-A57D-3000-C6C5-605F02673FF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501A1D9-4351-3352-4333-BBB999CA419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2E4370B-10AA-ED4F-ED95-7AA4B14BEE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C0657E-42FA-4F9A-99A4-C6AA05267C81}" type="datetimeFigureOut">
              <a:rPr lang="en-US" smtClean="0"/>
              <a:t>1/21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3A82006-F321-34F2-09B4-84442CA1B5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2EEA02D-EFA0-5182-F983-72E3021E71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A54FAF-3A03-421A-B73C-3C88FF03EB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42329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7AD52A-449E-AFDF-FAF5-9011E5101D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7B5E1D8-CDFC-4F56-C6DD-5D7B8E2C56C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0C953C1-B2D4-EE80-8EFC-4041801B79D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F3FD562-656C-3522-8103-3A32E84BE7B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DDC05F1-2F21-DE74-47B1-A1DA0EFFDE0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49C8018-B196-4840-DA48-0EE7BE7ABF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C0657E-42FA-4F9A-99A4-C6AA05267C81}" type="datetimeFigureOut">
              <a:rPr lang="en-US" smtClean="0"/>
              <a:t>1/21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E752F9E-E27A-DAAC-6079-87223A3827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5D8D7A9-F3D8-571D-11A5-623C0BDDE3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A54FAF-3A03-421A-B73C-3C88FF03EB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3399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89DB5D-8DC1-9444-CBB1-3777959C4A6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17AC7B2-A35A-0713-3C4D-072F0AAFBB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C0657E-42FA-4F9A-99A4-C6AA05267C81}" type="datetimeFigureOut">
              <a:rPr lang="en-US" smtClean="0"/>
              <a:t>1/21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26870E7-7A21-13DB-BDFF-2100F5FCFE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0B89251-1A6B-DAF7-F078-D4730BED70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A54FAF-3A03-421A-B73C-3C88FF03EB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51444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BF5B6A8-B76C-621B-20DD-69D38DE721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C0657E-42FA-4F9A-99A4-C6AA05267C81}" type="datetimeFigureOut">
              <a:rPr lang="en-US" smtClean="0"/>
              <a:t>1/21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23BCFAE-B759-5D6D-E85A-9213E33193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6CA3F66-482F-4537-E38A-7F96A45D2E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A54FAF-3A03-421A-B73C-3C88FF03EB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8946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B7914A5-1E48-0312-1DE2-EC929EE487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B0C2054-0B91-AE7A-7B70-C006ED6381C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783EB02-66EE-30AD-5679-3DADBEAF929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B8D5844-2392-832E-C070-36AA0DE25C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C0657E-42FA-4F9A-99A4-C6AA05267C81}" type="datetimeFigureOut">
              <a:rPr lang="en-US" smtClean="0"/>
              <a:t>1/21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9D64FDB-8C7B-5C74-A4BB-62ADBFE392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8B9DE59-5B48-32F8-D2D5-FE7B41A555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A54FAF-3A03-421A-B73C-3C88FF03EB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73769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47ED5F-F9C2-6AD4-48C1-DB47932B7B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F3F3F33-D955-B28A-03D4-A93D82A48AF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FEFD32D-BCCD-E686-9B75-0DD9D02AEAE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270D729-4BF1-28EF-DABC-C2A8C8AEAA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C0657E-42FA-4F9A-99A4-C6AA05267C81}" type="datetimeFigureOut">
              <a:rPr lang="en-US" smtClean="0"/>
              <a:t>1/21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09FEAD7-A48E-3B81-DC88-ABE7340574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75F5DDC-A0F5-5A59-C360-3D719F8EF3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A54FAF-3A03-421A-B73C-3C88FF03EB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43620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197165C-B2FB-2767-1483-0307287F16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9B26133-79EB-E2C2-4E0B-36879163790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6F7EDA7-F1BF-8462-7830-CE6B8BD8751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3C0657E-42FA-4F9A-99A4-C6AA05267C81}" type="datetimeFigureOut">
              <a:rPr lang="en-US" smtClean="0"/>
              <a:t>1/2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CC1E048-DE17-31A5-AB25-C07D2FE244F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93C422D-3D56-6198-446A-FE4E66C437E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5A54FAF-3A03-421A-B73C-3C88FF03EB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11019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collage of images of various objects&#10;&#10;Description automatically generated">
            <a:extLst>
              <a:ext uri="{FF2B5EF4-FFF2-40B4-BE49-F238E27FC236}">
                <a16:creationId xmlns:a16="http://schemas.microsoft.com/office/drawing/2014/main" id="{241B1C37-3A9A-27D6-2E23-CD5065B2153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3089" y="400153"/>
            <a:ext cx="10933642" cy="6239844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27691433-E2E6-A4F9-0007-58523AAE3924}"/>
              </a:ext>
            </a:extLst>
          </p:cNvPr>
          <p:cNvSpPr txBox="1"/>
          <p:nvPr/>
        </p:nvSpPr>
        <p:spPr>
          <a:xfrm>
            <a:off x="3294262" y="1816687"/>
            <a:ext cx="10615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Single cells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4078B285-1D09-2D37-49BE-FB5F58609F24}"/>
              </a:ext>
            </a:extLst>
          </p:cNvPr>
          <p:cNvSpPr txBox="1"/>
          <p:nvPr/>
        </p:nvSpPr>
        <p:spPr>
          <a:xfrm>
            <a:off x="1334206" y="1816688"/>
            <a:ext cx="5838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ells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49F0B9E-BFFF-C0ED-AC36-86654968EEA5}"/>
              </a:ext>
            </a:extLst>
          </p:cNvPr>
          <p:cNvSpPr txBox="1"/>
          <p:nvPr/>
        </p:nvSpPr>
        <p:spPr>
          <a:xfrm>
            <a:off x="5486698" y="218001"/>
            <a:ext cx="12186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Lymphocytes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2C4EE82-5136-7B2E-478D-E584C351C6F7}"/>
              </a:ext>
            </a:extLst>
          </p:cNvPr>
          <p:cNvSpPr txBox="1"/>
          <p:nvPr/>
        </p:nvSpPr>
        <p:spPr>
          <a:xfrm>
            <a:off x="10173579" y="218002"/>
            <a:ext cx="6767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T cells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85256B18-7DF1-3836-075D-067FE26D182B}"/>
              </a:ext>
            </a:extLst>
          </p:cNvPr>
          <p:cNvSpPr txBox="1"/>
          <p:nvPr/>
        </p:nvSpPr>
        <p:spPr>
          <a:xfrm>
            <a:off x="8357012" y="734274"/>
            <a:ext cx="6992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B cells</a:t>
            </a:r>
          </a:p>
        </p:txBody>
      </p: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57BA6CE7-C7B0-E591-AA3C-621277F651BB}"/>
              </a:ext>
            </a:extLst>
          </p:cNvPr>
          <p:cNvCxnSpPr/>
          <p:nvPr/>
        </p:nvCxnSpPr>
        <p:spPr>
          <a:xfrm>
            <a:off x="8986554" y="1816687"/>
            <a:ext cx="956789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85FE13C7-D829-7E09-A8D9-42F60B3C134E}"/>
              </a:ext>
            </a:extLst>
          </p:cNvPr>
          <p:cNvSpPr txBox="1"/>
          <p:nvPr/>
        </p:nvSpPr>
        <p:spPr>
          <a:xfrm>
            <a:off x="5312643" y="3366187"/>
            <a:ext cx="15667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Non-lymphocytes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8E81DFA2-37A6-5020-C1DF-B009FC617CA9}"/>
              </a:ext>
            </a:extLst>
          </p:cNvPr>
          <p:cNvSpPr txBox="1"/>
          <p:nvPr/>
        </p:nvSpPr>
        <p:spPr>
          <a:xfrm>
            <a:off x="8744297" y="3920565"/>
            <a:ext cx="6238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DC2</a:t>
            </a:r>
          </a:p>
        </p:txBody>
      </p:sp>
      <p:cxnSp>
        <p:nvCxnSpPr>
          <p:cNvPr id="17" name="Straight Arrow Connector 16">
            <a:extLst>
              <a:ext uri="{FF2B5EF4-FFF2-40B4-BE49-F238E27FC236}">
                <a16:creationId xmlns:a16="http://schemas.microsoft.com/office/drawing/2014/main" id="{F688D8E6-5BAB-7B71-EE6E-97D0D7B7BD35}"/>
              </a:ext>
            </a:extLst>
          </p:cNvPr>
          <p:cNvCxnSpPr>
            <a:cxnSpLocks/>
          </p:cNvCxnSpPr>
          <p:nvPr/>
        </p:nvCxnSpPr>
        <p:spPr>
          <a:xfrm flipV="1">
            <a:off x="8278045" y="3310459"/>
            <a:ext cx="876229" cy="43192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9" name="Straight Arrow Connector 18">
            <a:extLst>
              <a:ext uri="{FF2B5EF4-FFF2-40B4-BE49-F238E27FC236}">
                <a16:creationId xmlns:a16="http://schemas.microsoft.com/office/drawing/2014/main" id="{5A5FD2DD-8E9C-F6CD-0109-B480BB750ECF}"/>
              </a:ext>
            </a:extLst>
          </p:cNvPr>
          <p:cNvCxnSpPr>
            <a:cxnSpLocks/>
          </p:cNvCxnSpPr>
          <p:nvPr/>
        </p:nvCxnSpPr>
        <p:spPr>
          <a:xfrm>
            <a:off x="8792774" y="4838448"/>
            <a:ext cx="463419" cy="408163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1" name="TextBox 20">
            <a:extLst>
              <a:ext uri="{FF2B5EF4-FFF2-40B4-BE49-F238E27FC236}">
                <a16:creationId xmlns:a16="http://schemas.microsoft.com/office/drawing/2014/main" id="{9119CFC2-0FB9-0D56-CAF3-47DE3939C0D6}"/>
              </a:ext>
            </a:extLst>
          </p:cNvPr>
          <p:cNvSpPr txBox="1"/>
          <p:nvPr/>
        </p:nvSpPr>
        <p:spPr>
          <a:xfrm>
            <a:off x="10330872" y="2860830"/>
            <a:ext cx="109754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Neutrophils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04CE8738-4DB3-4299-39BF-CF594696D509}"/>
              </a:ext>
            </a:extLst>
          </p:cNvPr>
          <p:cNvSpPr txBox="1"/>
          <p:nvPr/>
        </p:nvSpPr>
        <p:spPr>
          <a:xfrm>
            <a:off x="10650970" y="4074453"/>
            <a:ext cx="12356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Macrophages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0FE86EFB-1016-C504-D0FC-D1C1C1DF8E45}"/>
              </a:ext>
            </a:extLst>
          </p:cNvPr>
          <p:cNvSpPr txBox="1"/>
          <p:nvPr/>
        </p:nvSpPr>
        <p:spPr>
          <a:xfrm>
            <a:off x="10414557" y="4782507"/>
            <a:ext cx="5341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/>
              <a:t>pDC</a:t>
            </a:r>
            <a:endParaRPr lang="en-US" sz="1400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91745CD4-88C1-12AB-FBA3-7CA08D20AF63}"/>
              </a:ext>
            </a:extLst>
          </p:cNvPr>
          <p:cNvSpPr txBox="1"/>
          <p:nvPr/>
        </p:nvSpPr>
        <p:spPr>
          <a:xfrm>
            <a:off x="10681617" y="6036022"/>
            <a:ext cx="6238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DC1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875CE7AA-76FE-A878-687B-D3B3F563BE23}"/>
              </a:ext>
            </a:extLst>
          </p:cNvPr>
          <p:cNvSpPr txBox="1"/>
          <p:nvPr/>
        </p:nvSpPr>
        <p:spPr>
          <a:xfrm>
            <a:off x="1281595" y="3853953"/>
            <a:ext cx="68903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FSC-A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A5BF809A-0B95-1E25-324F-0CB1614366F6}"/>
              </a:ext>
            </a:extLst>
          </p:cNvPr>
          <p:cNvSpPr txBox="1"/>
          <p:nvPr/>
        </p:nvSpPr>
        <p:spPr>
          <a:xfrm>
            <a:off x="3546400" y="3853952"/>
            <a:ext cx="68903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FSC-A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025A78FC-F094-5CB6-EC29-B3E4483079C3}"/>
              </a:ext>
            </a:extLst>
          </p:cNvPr>
          <p:cNvSpPr txBox="1"/>
          <p:nvPr/>
        </p:nvSpPr>
        <p:spPr>
          <a:xfrm rot="16200000">
            <a:off x="75278" y="2799696"/>
            <a:ext cx="7002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SSC-A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34AB0486-C5CD-93F3-CA21-D1831E995681}"/>
              </a:ext>
            </a:extLst>
          </p:cNvPr>
          <p:cNvSpPr txBox="1"/>
          <p:nvPr/>
        </p:nvSpPr>
        <p:spPr>
          <a:xfrm rot="16200000">
            <a:off x="2399631" y="2706941"/>
            <a:ext cx="70987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FSC-H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E980E508-A3BF-6FFC-44CD-CE07CAC103A3}"/>
              </a:ext>
            </a:extLst>
          </p:cNvPr>
          <p:cNvSpPr txBox="1"/>
          <p:nvPr/>
        </p:nvSpPr>
        <p:spPr>
          <a:xfrm>
            <a:off x="5659338" y="2318562"/>
            <a:ext cx="68903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FSC-A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FCFCE70C-46BC-BF98-94C0-E9D4233543AB}"/>
              </a:ext>
            </a:extLst>
          </p:cNvPr>
          <p:cNvSpPr txBox="1"/>
          <p:nvPr/>
        </p:nvSpPr>
        <p:spPr>
          <a:xfrm rot="16200000">
            <a:off x="4556445" y="1170733"/>
            <a:ext cx="7002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SSC-A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F50ACDB4-7614-7B65-3F2A-869F5699EAAB}"/>
              </a:ext>
            </a:extLst>
          </p:cNvPr>
          <p:cNvSpPr txBox="1"/>
          <p:nvPr/>
        </p:nvSpPr>
        <p:spPr>
          <a:xfrm>
            <a:off x="8062475" y="2238544"/>
            <a:ext cx="5838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B220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8E08EAAD-91C1-DBD4-388E-575BC7C002A5}"/>
              </a:ext>
            </a:extLst>
          </p:cNvPr>
          <p:cNvSpPr txBox="1"/>
          <p:nvPr/>
        </p:nvSpPr>
        <p:spPr>
          <a:xfrm>
            <a:off x="10355817" y="2235271"/>
            <a:ext cx="5341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CD3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3CC738AB-9E28-71CC-4E04-821FA2A4E8FF}"/>
              </a:ext>
            </a:extLst>
          </p:cNvPr>
          <p:cNvSpPr txBox="1"/>
          <p:nvPr/>
        </p:nvSpPr>
        <p:spPr>
          <a:xfrm>
            <a:off x="10229334" y="4467838"/>
            <a:ext cx="6383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F4/80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0D632C15-A1B1-9B87-69E7-280F82EFA6B7}"/>
              </a:ext>
            </a:extLst>
          </p:cNvPr>
          <p:cNvSpPr txBox="1"/>
          <p:nvPr/>
        </p:nvSpPr>
        <p:spPr>
          <a:xfrm>
            <a:off x="10312674" y="6460908"/>
            <a:ext cx="5341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CD8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5737ACDF-B3C8-86FC-1328-EEC1ECE12E87}"/>
              </a:ext>
            </a:extLst>
          </p:cNvPr>
          <p:cNvSpPr txBox="1"/>
          <p:nvPr/>
        </p:nvSpPr>
        <p:spPr>
          <a:xfrm>
            <a:off x="7978543" y="5326702"/>
            <a:ext cx="72808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CD11c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D747C8F9-2D9C-6713-48E7-91A5E6A8BA02}"/>
              </a:ext>
            </a:extLst>
          </p:cNvPr>
          <p:cNvSpPr txBox="1"/>
          <p:nvPr/>
        </p:nvSpPr>
        <p:spPr>
          <a:xfrm>
            <a:off x="5736794" y="5341065"/>
            <a:ext cx="5341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CD3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1F5ABD2E-A619-A1C3-8BFF-E1E77CA7B0B8}"/>
              </a:ext>
            </a:extLst>
          </p:cNvPr>
          <p:cNvSpPr txBox="1"/>
          <p:nvPr/>
        </p:nvSpPr>
        <p:spPr>
          <a:xfrm rot="16200000">
            <a:off x="6880450" y="1084401"/>
            <a:ext cx="63030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CD19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CEB0D236-65C9-CFB9-969F-FE584AA3B509}"/>
              </a:ext>
            </a:extLst>
          </p:cNvPr>
          <p:cNvSpPr txBox="1"/>
          <p:nvPr/>
        </p:nvSpPr>
        <p:spPr>
          <a:xfrm rot="16200000">
            <a:off x="9094931" y="1118159"/>
            <a:ext cx="63030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CD19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9DA1AD28-FADC-D88B-2F42-63DBBF7FEA1D}"/>
              </a:ext>
            </a:extLst>
          </p:cNvPr>
          <p:cNvSpPr txBox="1"/>
          <p:nvPr/>
        </p:nvSpPr>
        <p:spPr>
          <a:xfrm rot="16200000">
            <a:off x="4663751" y="4313949"/>
            <a:ext cx="63030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CD19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0EADA9F1-0A86-5545-6309-B1D5229A9229}"/>
              </a:ext>
            </a:extLst>
          </p:cNvPr>
          <p:cNvSpPr txBox="1"/>
          <p:nvPr/>
        </p:nvSpPr>
        <p:spPr>
          <a:xfrm rot="16200000">
            <a:off x="6810541" y="4271598"/>
            <a:ext cx="73609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CD11b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AB0CF876-5FE2-A225-0E56-629BB22A5888}"/>
              </a:ext>
            </a:extLst>
          </p:cNvPr>
          <p:cNvSpPr txBox="1"/>
          <p:nvPr/>
        </p:nvSpPr>
        <p:spPr>
          <a:xfrm rot="16200000">
            <a:off x="9086243" y="3275112"/>
            <a:ext cx="6476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Ly-6G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6ACC86C3-3DC6-A45A-B101-DBEE50AD00FA}"/>
              </a:ext>
            </a:extLst>
          </p:cNvPr>
          <p:cNvSpPr txBox="1"/>
          <p:nvPr/>
        </p:nvSpPr>
        <p:spPr>
          <a:xfrm rot="16200000">
            <a:off x="9136340" y="5341064"/>
            <a:ext cx="5838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B220</a:t>
            </a:r>
          </a:p>
        </p:txBody>
      </p:sp>
    </p:spTree>
    <p:extLst>
      <p:ext uri="{BB962C8B-B14F-4D97-AF65-F5344CB8AC3E}">
        <p14:creationId xmlns:p14="http://schemas.microsoft.com/office/powerpoint/2010/main" val="33575434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1</TotalTime>
  <Words>32</Words>
  <Application>Microsoft Office PowerPoint</Application>
  <PresentationFormat>Widescreen</PresentationFormat>
  <Paragraphs>2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>Oregon Health and Science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Nobuyo Mizuno</dc:creator>
  <cp:lastModifiedBy>Nobuyo Mizuno</cp:lastModifiedBy>
  <cp:revision>1</cp:revision>
  <dcterms:created xsi:type="dcterms:W3CDTF">2025-01-21T21:31:08Z</dcterms:created>
  <dcterms:modified xsi:type="dcterms:W3CDTF">2025-01-21T21:53:00Z</dcterms:modified>
</cp:coreProperties>
</file>